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9" d="100"/>
          <a:sy n="69" d="100"/>
        </p:scale>
        <p:origin x="119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WASAKI-PC\Desktop\24&#31958;&#23615;&#30149;&#32207;&#20250;&#65288;&#26481;&#20140;&#65289;\3%20Screen%20ICA&#25239;&#20307;&#20385;&#65288;&#24029;&#64017;&#65289;\3%20Screen%20ICA&#25239;&#20307;&#20385;&#35299;&#26512;\3&#25239;&#20307;&#38512;&#24615;&#32773;_Acute+SP%20(n=204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270009231223491"/>
          <c:y val="7.9377483555631304E-2"/>
          <c:w val="0.64371844173486437"/>
          <c:h val="0.77020926827928637"/>
        </c:manualLayout>
      </c:layout>
      <c:scatterChart>
        <c:scatterStyle val="lineMarker"/>
        <c:varyColors val="0"/>
        <c:ser>
          <c:idx val="0"/>
          <c:order val="0"/>
          <c:tx>
            <c:strRef>
              <c:f>'ROC-GADA'!$A$45</c:f>
              <c:strCache>
                <c:ptCount val="1"/>
                <c:pt idx="0">
                  <c:v>GADA</c:v>
                </c:pt>
              </c:strCache>
            </c:strRef>
          </c:tx>
          <c:spPr>
            <a:ln w="25400">
              <a:solidFill>
                <a:schemeClr val="tx1"/>
              </a:solidFill>
              <a:prstDash val="solid"/>
            </a:ln>
          </c:spPr>
          <c:marker>
            <c:symbol val="diamond"/>
            <c:size val="10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olid"/>
              </a:ln>
            </c:spPr>
          </c:marker>
          <c:xVal>
            <c:numRef>
              <c:f>'ROC-GADA'!$B$47:$B$88</c:f>
              <c:numCache>
                <c:formatCode>0.0000</c:formatCode>
                <c:ptCount val="42"/>
                <c:pt idx="0">
                  <c:v>1</c:v>
                </c:pt>
                <c:pt idx="1">
                  <c:v>0.76756756756756761</c:v>
                </c:pt>
                <c:pt idx="2">
                  <c:v>0.67027027027027031</c:v>
                </c:pt>
                <c:pt idx="3">
                  <c:v>0.61621621621621625</c:v>
                </c:pt>
                <c:pt idx="4">
                  <c:v>0.55135135135135138</c:v>
                </c:pt>
                <c:pt idx="5">
                  <c:v>0.50810810810810814</c:v>
                </c:pt>
                <c:pt idx="6">
                  <c:v>0.44324324324324327</c:v>
                </c:pt>
                <c:pt idx="7">
                  <c:v>0.34594594594594597</c:v>
                </c:pt>
                <c:pt idx="8">
                  <c:v>0.27567567567567569</c:v>
                </c:pt>
                <c:pt idx="9">
                  <c:v>0.24324324324324326</c:v>
                </c:pt>
                <c:pt idx="10">
                  <c:v>0.22162162162162163</c:v>
                </c:pt>
                <c:pt idx="11">
                  <c:v>0.20540540540540542</c:v>
                </c:pt>
                <c:pt idx="12">
                  <c:v>0.17297297297297298</c:v>
                </c:pt>
                <c:pt idx="13">
                  <c:v>0.16756756756756758</c:v>
                </c:pt>
                <c:pt idx="14">
                  <c:v>0.16216216216216217</c:v>
                </c:pt>
                <c:pt idx="15">
                  <c:v>0.15675675675675677</c:v>
                </c:pt>
                <c:pt idx="16">
                  <c:v>0.14054054054054055</c:v>
                </c:pt>
                <c:pt idx="17">
                  <c:v>0.13513513513513514</c:v>
                </c:pt>
                <c:pt idx="18">
                  <c:v>0.12972972972972974</c:v>
                </c:pt>
                <c:pt idx="19">
                  <c:v>0.12432432432432433</c:v>
                </c:pt>
                <c:pt idx="20">
                  <c:v>0.11351351351351352</c:v>
                </c:pt>
                <c:pt idx="21">
                  <c:v>0.10270270270270271</c:v>
                </c:pt>
                <c:pt idx="22">
                  <c:v>9.1891891891891897E-2</c:v>
                </c:pt>
                <c:pt idx="23">
                  <c:v>9.1891891891891897E-2</c:v>
                </c:pt>
                <c:pt idx="24">
                  <c:v>8.1081081081081086E-2</c:v>
                </c:pt>
                <c:pt idx="25">
                  <c:v>7.567567567567568E-2</c:v>
                </c:pt>
                <c:pt idx="26">
                  <c:v>6.4864864864864868E-2</c:v>
                </c:pt>
                <c:pt idx="27">
                  <c:v>4.8648648648648651E-2</c:v>
                </c:pt>
                <c:pt idx="28">
                  <c:v>4.3243243243243246E-2</c:v>
                </c:pt>
                <c:pt idx="29">
                  <c:v>3.783783783783784E-2</c:v>
                </c:pt>
                <c:pt idx="30">
                  <c:v>3.783783783783784E-2</c:v>
                </c:pt>
                <c:pt idx="31">
                  <c:v>1.6216216216216217E-2</c:v>
                </c:pt>
                <c:pt idx="32">
                  <c:v>1.6216216216216217E-2</c:v>
                </c:pt>
                <c:pt idx="33">
                  <c:v>1.6216216216216217E-2</c:v>
                </c:pt>
                <c:pt idx="34">
                  <c:v>1.6216216216216217E-2</c:v>
                </c:pt>
                <c:pt idx="35">
                  <c:v>1.6216216216216217E-2</c:v>
                </c:pt>
                <c:pt idx="36">
                  <c:v>1.6216216216216217E-2</c:v>
                </c:pt>
                <c:pt idx="37">
                  <c:v>5.4054054054054057E-3</c:v>
                </c:pt>
                <c:pt idx="38">
                  <c:v>5.4054054054054057E-3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</c:numCache>
            </c:numRef>
          </c:xVal>
          <c:yVal>
            <c:numRef>
              <c:f>'ROC-GADA'!$C$47:$C$88</c:f>
              <c:numCache>
                <c:formatCode>0.0000</c:formatCode>
                <c:ptCount val="4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0.94736842105263153</c:v>
                </c:pt>
                <c:pt idx="16">
                  <c:v>0.94736842105263153</c:v>
                </c:pt>
                <c:pt idx="17">
                  <c:v>0.94736842105263153</c:v>
                </c:pt>
                <c:pt idx="18">
                  <c:v>0.94736842105263153</c:v>
                </c:pt>
                <c:pt idx="19">
                  <c:v>0.94736842105263153</c:v>
                </c:pt>
                <c:pt idx="20">
                  <c:v>0.94736842105263153</c:v>
                </c:pt>
                <c:pt idx="21">
                  <c:v>0.94736842105263153</c:v>
                </c:pt>
                <c:pt idx="22">
                  <c:v>0.89473684210526316</c:v>
                </c:pt>
                <c:pt idx="23">
                  <c:v>0.84210526315789469</c:v>
                </c:pt>
                <c:pt idx="24">
                  <c:v>0.84210526315789469</c:v>
                </c:pt>
                <c:pt idx="25">
                  <c:v>0.84210526315789469</c:v>
                </c:pt>
                <c:pt idx="26">
                  <c:v>0.84210526315789469</c:v>
                </c:pt>
                <c:pt idx="27">
                  <c:v>0.84210526315789469</c:v>
                </c:pt>
                <c:pt idx="28">
                  <c:v>0.84210526315789469</c:v>
                </c:pt>
                <c:pt idx="29">
                  <c:v>0.78947368421052633</c:v>
                </c:pt>
                <c:pt idx="30">
                  <c:v>0.68421052631578949</c:v>
                </c:pt>
                <c:pt idx="31">
                  <c:v>0.52631578947368418</c:v>
                </c:pt>
                <c:pt idx="32">
                  <c:v>0.47368421052631576</c:v>
                </c:pt>
                <c:pt idx="33">
                  <c:v>0.42105263157894735</c:v>
                </c:pt>
                <c:pt idx="34">
                  <c:v>0.36842105263157893</c:v>
                </c:pt>
                <c:pt idx="35">
                  <c:v>0.31578947368421051</c:v>
                </c:pt>
                <c:pt idx="36">
                  <c:v>0.26315789473684209</c:v>
                </c:pt>
                <c:pt idx="37">
                  <c:v>0.26315789473684209</c:v>
                </c:pt>
                <c:pt idx="38">
                  <c:v>0.15789473684210525</c:v>
                </c:pt>
                <c:pt idx="39">
                  <c:v>0.15789473684210525</c:v>
                </c:pt>
                <c:pt idx="40">
                  <c:v>5.2631578947368418E-2</c:v>
                </c:pt>
                <c:pt idx="41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DDB-4087-8D39-DB88377C12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75315551"/>
        <c:axId val="558692959"/>
      </c:scatterChart>
      <c:valAx>
        <c:axId val="1975315551"/>
        <c:scaling>
          <c:orientation val="minMax"/>
          <c:max val="1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8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ja-JP" sz="18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1-Specificity</a:t>
                </a:r>
                <a:endParaRPr lang="ja-JP" altLang="en-US" sz="18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3861082254149048"/>
              <c:y val="0.92915788495244322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558692959"/>
        <c:crosses val="autoZero"/>
        <c:crossBetween val="midCat"/>
        <c:majorUnit val="0.2"/>
      </c:valAx>
      <c:valAx>
        <c:axId val="558692959"/>
        <c:scaling>
          <c:orientation val="minMax"/>
          <c:max val="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8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ja-JP" sz="18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Sensitivity</a:t>
                </a:r>
                <a:endParaRPr lang="ja-JP" altLang="en-US" sz="18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5040388630723479E-2"/>
              <c:y val="0.37300655380535475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975315551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1814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496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2000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245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1267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192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968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4157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8089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354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7865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8106BC-AF2A-4355-98A6-2EED613120DA}" type="datetimeFigureOut">
              <a:rPr kumimoji="1" lang="ja-JP" altLang="en-US" smtClean="0"/>
              <a:t>2024/6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4666FF-635A-454F-B831-468DD4051D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1324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35E726F9-EB98-46A9-8D6E-0685E560C44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70960961"/>
              </p:ext>
            </p:extLst>
          </p:nvPr>
        </p:nvGraphicFramePr>
        <p:xfrm>
          <a:off x="1440951" y="-9"/>
          <a:ext cx="7396636" cy="56803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9BE7EA1-05EE-4B47-96EB-8DA9DB513CFB}"/>
              </a:ext>
            </a:extLst>
          </p:cNvPr>
          <p:cNvSpPr txBox="1"/>
          <p:nvPr/>
        </p:nvSpPr>
        <p:spPr>
          <a:xfrm>
            <a:off x="5639262" y="3430261"/>
            <a:ext cx="189891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ut-off: 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2.2U/mL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ensitivity: 0.95</a:t>
            </a: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pecificity: 0.90</a:t>
            </a:r>
          </a:p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UC: 0.97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13E2999D-A07B-4800-B637-31CAD831FD55}"/>
              </a:ext>
            </a:extLst>
          </p:cNvPr>
          <p:cNvCxnSpPr/>
          <p:nvPr/>
        </p:nvCxnSpPr>
        <p:spPr>
          <a:xfrm>
            <a:off x="2784763" y="447894"/>
            <a:ext cx="207819" cy="1894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4511190-5157-4A98-A44C-CF4AA529DB4E}"/>
              </a:ext>
            </a:extLst>
          </p:cNvPr>
          <p:cNvSpPr txBox="1"/>
          <p:nvPr/>
        </p:nvSpPr>
        <p:spPr>
          <a:xfrm>
            <a:off x="98958" y="5648275"/>
            <a:ext cx="971005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  Optimal cut-off values of GADA titer for 3 Screen ICA positivity in individual autoantibody-negative patients with ROC curve analysis. </a:t>
            </a:r>
          </a:p>
          <a:p>
            <a:r>
              <a:rPr lang="en-US" altLang="ja-JP" sz="14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optimal cut-off value of the sum of three individual autoantibodies for distinguishing between 3 Screen ICA-positive and -negative patients was determined to be 2.2 U/mL (95% sensitivity, 90% specificity). Arrows indicate the cut-off points. AUC, area under the curve.</a:t>
            </a:r>
          </a:p>
        </p:txBody>
      </p:sp>
    </p:spTree>
    <p:extLst>
      <p:ext uri="{BB962C8B-B14F-4D97-AF65-F5344CB8AC3E}">
        <p14:creationId xmlns:p14="http://schemas.microsoft.com/office/powerpoint/2010/main" val="25966021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2</TotalTime>
  <Words>89</Words>
  <Application>Microsoft Office PowerPoint</Application>
  <PresentationFormat>A4 210 x 297 mm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SimSun</vt:lpstr>
      <vt:lpstr>游ゴシック</vt:lpstr>
      <vt:lpstr>游ゴシック Light</vt:lpstr>
      <vt:lpstr>Arial</vt:lpstr>
      <vt:lpstr>Calibri</vt:lpstr>
      <vt:lpstr>Calibri Light</vt:lpstr>
      <vt:lpstr>Palatino Linotype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WASAKI-PC</dc:creator>
  <cp:lastModifiedBy>KAWASAKI-PC</cp:lastModifiedBy>
  <cp:revision>30</cp:revision>
  <dcterms:created xsi:type="dcterms:W3CDTF">2024-05-05T07:24:37Z</dcterms:created>
  <dcterms:modified xsi:type="dcterms:W3CDTF">2024-06-10T06:33:08Z</dcterms:modified>
</cp:coreProperties>
</file>